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FE2EDB2-0B34-4DD9-9837-FDE97B279719}" v="1" dt="2024-10-10T07:11:04.781"/>
    <p1510:client id="{6E943017-D3DE-4C49-BAD4-25EFFDBB32E4}" v="1" dt="2024-10-10T06:51:07.34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34" autoAdjust="0"/>
    <p:restoredTop sz="94660"/>
  </p:normalViewPr>
  <p:slideViewPr>
    <p:cSldViewPr snapToGrid="0">
      <p:cViewPr varScale="1">
        <p:scale>
          <a:sx n="73" d="100"/>
          <a:sy n="73" d="100"/>
        </p:scale>
        <p:origin x="190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赤堀　ゆきこ" userId="bbfeda90-9ade-440e-995a-5a1e8cff3baf" providerId="ADAL" clId="{1FE2EDB2-0B34-4DD9-9837-FDE97B279719}"/>
    <pc:docChg chg="addSld delSld modSld">
      <pc:chgData name="赤堀　ゆきこ" userId="bbfeda90-9ade-440e-995a-5a1e8cff3baf" providerId="ADAL" clId="{1FE2EDB2-0B34-4DD9-9837-FDE97B279719}" dt="2024-10-10T07:18:42.067" v="4" actId="2711"/>
      <pc:docMkLst>
        <pc:docMk/>
      </pc:docMkLst>
      <pc:sldChg chg="del">
        <pc:chgData name="赤堀　ゆきこ" userId="bbfeda90-9ade-440e-995a-5a1e8cff3baf" providerId="ADAL" clId="{1FE2EDB2-0B34-4DD9-9837-FDE97B279719}" dt="2024-10-10T07:11:06.415" v="1" actId="47"/>
        <pc:sldMkLst>
          <pc:docMk/>
          <pc:sldMk cId="3223437358" sldId="261"/>
        </pc:sldMkLst>
      </pc:sldChg>
      <pc:sldChg chg="modSp add mod">
        <pc:chgData name="赤堀　ゆきこ" userId="bbfeda90-9ade-440e-995a-5a1e8cff3baf" providerId="ADAL" clId="{1FE2EDB2-0B34-4DD9-9837-FDE97B279719}" dt="2024-10-10T07:18:42.067" v="4" actId="2711"/>
        <pc:sldMkLst>
          <pc:docMk/>
          <pc:sldMk cId="1150512429" sldId="264"/>
        </pc:sldMkLst>
        <pc:graphicFrameChg chg="modGraphic">
          <ac:chgData name="赤堀　ゆきこ" userId="bbfeda90-9ade-440e-995a-5a1e8cff3baf" providerId="ADAL" clId="{1FE2EDB2-0B34-4DD9-9837-FDE97B279719}" dt="2024-10-10T07:18:42.067" v="4" actId="2711"/>
          <ac:graphicFrameMkLst>
            <pc:docMk/>
            <pc:sldMk cId="1150512429" sldId="264"/>
            <ac:graphicFrameMk id="4" creationId="{3B79122C-7ECE-E3E2-635A-F5E93202F8FA}"/>
          </ac:graphicFrameMkLst>
        </pc:graphicFrameChg>
      </pc:sldChg>
    </pc:docChg>
  </pc:docChgLst>
  <pc:docChgLst>
    <pc:chgData name="赤堀　ゆきこ" userId="bbfeda90-9ade-440e-995a-5a1e8cff3baf" providerId="ADAL" clId="{6E943017-D3DE-4C49-BAD4-25EFFDBB32E4}"/>
    <pc:docChg chg="addSld delSld modSld">
      <pc:chgData name="赤堀　ゆきこ" userId="bbfeda90-9ade-440e-995a-5a1e8cff3baf" providerId="ADAL" clId="{6E943017-D3DE-4C49-BAD4-25EFFDBB32E4}" dt="2024-10-10T07:08:13.320" v="5" actId="12788"/>
      <pc:docMkLst>
        <pc:docMk/>
      </pc:docMkLst>
      <pc:sldChg chg="modSp add mod">
        <pc:chgData name="赤堀　ゆきこ" userId="bbfeda90-9ade-440e-995a-5a1e8cff3baf" providerId="ADAL" clId="{6E943017-D3DE-4C49-BAD4-25EFFDBB32E4}" dt="2024-10-10T07:08:13.320" v="5" actId="12788"/>
        <pc:sldMkLst>
          <pc:docMk/>
          <pc:sldMk cId="3223437358" sldId="261"/>
        </pc:sldMkLst>
        <pc:spChg chg="mod">
          <ac:chgData name="赤堀　ゆきこ" userId="bbfeda90-9ade-440e-995a-5a1e8cff3baf" providerId="ADAL" clId="{6E943017-D3DE-4C49-BAD4-25EFFDBB32E4}" dt="2024-10-10T07:08:02.005" v="2" actId="255"/>
          <ac:spMkLst>
            <pc:docMk/>
            <pc:sldMk cId="3223437358" sldId="261"/>
            <ac:spMk id="5" creationId="{1077F836-F8F0-C8B0-A602-8CAEAED7357E}"/>
          </ac:spMkLst>
        </pc:spChg>
        <pc:graphicFrameChg chg="mod modGraphic">
          <ac:chgData name="赤堀　ゆきこ" userId="bbfeda90-9ade-440e-995a-5a1e8cff3baf" providerId="ADAL" clId="{6E943017-D3DE-4C49-BAD4-25EFFDBB32E4}" dt="2024-10-10T07:08:13.320" v="5" actId="12788"/>
          <ac:graphicFrameMkLst>
            <pc:docMk/>
            <pc:sldMk cId="3223437358" sldId="261"/>
            <ac:graphicFrameMk id="4" creationId="{5D8EE5DF-E8F6-36B1-94AD-C440A19102F6}"/>
          </ac:graphicFrameMkLst>
        </pc:graphicFrameChg>
      </pc:sldChg>
      <pc:sldChg chg="del">
        <pc:chgData name="赤堀　ゆきこ" userId="bbfeda90-9ade-440e-995a-5a1e8cff3baf" providerId="ADAL" clId="{6E943017-D3DE-4C49-BAD4-25EFFDBB32E4}" dt="2024-10-10T06:51:08.889" v="1" actId="47"/>
        <pc:sldMkLst>
          <pc:docMk/>
          <pc:sldMk cId="13072062" sldId="263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7227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8949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5262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5383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67064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2636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6365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35102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96126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7639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0616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72E0BBB-3399-4401-875A-1370C28E4E37}" type="datetimeFigureOut">
              <a:rPr kumimoji="1" lang="ja-JP" altLang="en-US" smtClean="0"/>
              <a:t>2024/10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CA8580-E68A-4957-9555-572C0B1A60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33147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FDD177D-54D0-4307-F71F-74D18DBADB39}"/>
              </a:ext>
            </a:extLst>
          </p:cNvPr>
          <p:cNvSpPr txBox="1"/>
          <p:nvPr/>
        </p:nvSpPr>
        <p:spPr>
          <a:xfrm>
            <a:off x="813777" y="3248442"/>
            <a:ext cx="23695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3 Table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BC value of serotypes 1 and 3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85B5138-BB60-FC0E-EB17-9516FC4597EB}"/>
              </a:ext>
            </a:extLst>
          </p:cNvPr>
          <p:cNvSpPr txBox="1"/>
          <p:nvPr/>
        </p:nvSpPr>
        <p:spPr>
          <a:xfrm>
            <a:off x="813777" y="2793452"/>
            <a:ext cx="1552028" cy="2551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8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</a:t>
            </a:r>
            <a:endParaRPr lang="ja-JP" altLang="en-US" sz="105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3B79122C-7ECE-E3E2-635A-F5E93202F8F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99902486"/>
              </p:ext>
            </p:extLst>
          </p:nvPr>
        </p:nvGraphicFramePr>
        <p:xfrm>
          <a:off x="522514" y="3866233"/>
          <a:ext cx="5904409" cy="1005840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077447">
                  <a:extLst>
                    <a:ext uri="{9D8B030D-6E8A-4147-A177-3AD203B41FA5}">
                      <a16:colId xmlns:a16="http://schemas.microsoft.com/office/drawing/2014/main" val="1976928964"/>
                    </a:ext>
                  </a:extLst>
                </a:gridCol>
                <a:gridCol w="689566">
                  <a:extLst>
                    <a:ext uri="{9D8B030D-6E8A-4147-A177-3AD203B41FA5}">
                      <a16:colId xmlns:a16="http://schemas.microsoft.com/office/drawing/2014/main" val="21703623"/>
                    </a:ext>
                  </a:extLst>
                </a:gridCol>
                <a:gridCol w="689566">
                  <a:extLst>
                    <a:ext uri="{9D8B030D-6E8A-4147-A177-3AD203B41FA5}">
                      <a16:colId xmlns:a16="http://schemas.microsoft.com/office/drawing/2014/main" val="3521675195"/>
                    </a:ext>
                  </a:extLst>
                </a:gridCol>
                <a:gridCol w="689566">
                  <a:extLst>
                    <a:ext uri="{9D8B030D-6E8A-4147-A177-3AD203B41FA5}">
                      <a16:colId xmlns:a16="http://schemas.microsoft.com/office/drawing/2014/main" val="1925787993"/>
                    </a:ext>
                  </a:extLst>
                </a:gridCol>
                <a:gridCol w="689566">
                  <a:extLst>
                    <a:ext uri="{9D8B030D-6E8A-4147-A177-3AD203B41FA5}">
                      <a16:colId xmlns:a16="http://schemas.microsoft.com/office/drawing/2014/main" val="3494011127"/>
                    </a:ext>
                  </a:extLst>
                </a:gridCol>
                <a:gridCol w="689566">
                  <a:extLst>
                    <a:ext uri="{9D8B030D-6E8A-4147-A177-3AD203B41FA5}">
                      <a16:colId xmlns:a16="http://schemas.microsoft.com/office/drawing/2014/main" val="2132050033"/>
                    </a:ext>
                  </a:extLst>
                </a:gridCol>
                <a:gridCol w="689566">
                  <a:extLst>
                    <a:ext uri="{9D8B030D-6E8A-4147-A177-3AD203B41FA5}">
                      <a16:colId xmlns:a16="http://schemas.microsoft.com/office/drawing/2014/main" val="499597001"/>
                    </a:ext>
                  </a:extLst>
                </a:gridCol>
                <a:gridCol w="689566">
                  <a:extLst>
                    <a:ext uri="{9D8B030D-6E8A-4147-A177-3AD203B41FA5}">
                      <a16:colId xmlns:a16="http://schemas.microsoft.com/office/drawing/2014/main" val="55625773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biotics</a:t>
                      </a:r>
                    </a:p>
                    <a:p>
                      <a:r>
                        <a:rPr kumimoji="1" lang="en-US" altLang="ja-JP" sz="1200" dirty="0"/>
                        <a:t>(</a:t>
                      </a:r>
                      <a:r>
                        <a:rPr lang="en-US" altLang="ja-JP" sz="1200" b="1" u="none" strike="noStrike" dirty="0">
                          <a:effectLst/>
                          <a:latin typeface="Symbol" panose="05050102010706020507" pitchFamily="18" charset="2"/>
                          <a:cs typeface="Arial" panose="020B0604020202020204" pitchFamily="34" charset="0"/>
                        </a:rPr>
                        <a:t>m</a:t>
                      </a:r>
                      <a:r>
                        <a:rPr lang="en-US" altLang="ja-JP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mL</a:t>
                      </a:r>
                      <a:r>
                        <a:rPr kumimoji="1" lang="en-US" altLang="ja-JP" sz="1200" dirty="0"/>
                        <a:t>)</a:t>
                      </a:r>
                      <a:endParaRPr kumimoji="1" lang="ja-JP" alt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G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PM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M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TX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PM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DM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VFX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55117629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type 1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anchor="ctr">
                    <a:solidFill>
                      <a:schemeClr val="bg1">
                        <a:alpha val="2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48197959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r>
                        <a:rPr kumimoji="1" lang="en-US" altLang="ja-JP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otype 3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</a:t>
                      </a:r>
                      <a:endParaRPr kumimoji="1" lang="ja-JP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&gt;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ja-JP" altLang="en-US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≦</a:t>
                      </a:r>
                      <a:r>
                        <a:rPr lang="en-US" altLang="ja-JP" sz="120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2</a:t>
                      </a:r>
                      <a:endParaRPr lang="en-US" altLang="ja-JP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03346516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505124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53</Words>
  <Application>Microsoft Office PowerPoint</Application>
  <PresentationFormat>A4 210 x 297 mm</PresentationFormat>
  <Paragraphs>2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赤堀　ゆきこ</dc:creator>
  <cp:lastModifiedBy>赤堀　ゆきこ</cp:lastModifiedBy>
  <cp:revision>6</cp:revision>
  <dcterms:created xsi:type="dcterms:W3CDTF">2024-10-10T06:46:11Z</dcterms:created>
  <dcterms:modified xsi:type="dcterms:W3CDTF">2024-10-10T07:18:51Z</dcterms:modified>
</cp:coreProperties>
</file>